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80" autoAdjust="0"/>
    <p:restoredTop sz="86957" autoAdjust="0"/>
  </p:normalViewPr>
  <p:slideViewPr>
    <p:cSldViewPr snapToGrid="0">
      <p:cViewPr varScale="1">
        <p:scale>
          <a:sx n="99" d="100"/>
          <a:sy n="99" d="100"/>
        </p:scale>
        <p:origin x="91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FDEDAAD-472E-40AA-98F8-E8871031D4CF}" type="datetimeFigureOut">
              <a:rPr lang="en-AU" smtClean="0"/>
              <a:t>1/03/2024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CE96F4F-A344-40EA-8190-04D91A04B9D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447642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AU" b="1" dirty="0"/>
              <a:t>Figure S1. </a:t>
            </a:r>
            <a:r>
              <a:rPr lang="en-AU" b="1" i="1" dirty="0"/>
              <a:t>TMPRSS15</a:t>
            </a:r>
            <a:r>
              <a:rPr lang="en-AU" b="1" i="0" dirty="0"/>
              <a:t> is expressed primarily in small intestinal tissue.</a:t>
            </a:r>
            <a:r>
              <a:rPr lang="en-AU" b="0" i="0" dirty="0"/>
              <a:t> Plot from the Genotype-Tissue Expression (</a:t>
            </a:r>
            <a:r>
              <a:rPr lang="en-AU" b="0" i="0" dirty="0" err="1"/>
              <a:t>GTEx</a:t>
            </a:r>
            <a:r>
              <a:rPr lang="en-AU" b="0" i="0" dirty="0"/>
              <a:t>) project showing </a:t>
            </a:r>
            <a:r>
              <a:rPr lang="en-AU" b="0" i="1" dirty="0"/>
              <a:t>TMPRSS15</a:t>
            </a:r>
            <a:r>
              <a:rPr lang="en-AU" b="0" i="0" dirty="0"/>
              <a:t> mRNA expression across 49 human tissues. TPM: transcripts per million.</a:t>
            </a:r>
            <a:endParaRPr lang="en-AU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CE96F4F-A344-40EA-8190-04D91A04B9D6}" type="slidenum">
              <a:rPr lang="en-AU" smtClean="0"/>
              <a:t>1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756349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F3F6DB-E6EB-E05B-1378-991F8CCAFED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AE57026-2600-701C-421A-920C54051C9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0C51EB-F7E5-3E85-D8CA-28D42B43BA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C7CD-83CD-4A60-979F-C46E1E8B2DB0}" type="datetimeFigureOut">
              <a:rPr lang="en-AU" smtClean="0"/>
              <a:t>1/03/2024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EED6D9-A62C-0AB4-AAF9-C387683361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472005-8E64-A1BA-B632-AA1C0DC6CE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0A19F-274B-46F8-BC63-B4A9E085F61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453334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2D9FE4-9E33-1131-A0CE-C785E12295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6C45AA0-5556-EC7A-C142-DC4922BD0E9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E9E5B6-FE6E-C514-280A-0A4B335055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C7CD-83CD-4A60-979F-C46E1E8B2DB0}" type="datetimeFigureOut">
              <a:rPr lang="en-AU" smtClean="0"/>
              <a:t>1/03/2024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F5749E-8256-9285-6AAF-AF9DE0FC07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170D2A-D3AE-3ECD-AC2B-30563EA440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0A19F-274B-46F8-BC63-B4A9E085F61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873339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C83DAAD-3160-9E4D-8182-831F0890991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61FE699-CBAD-FCD9-225A-85FCB72984C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DC823B-EE18-16B3-E41F-DFC564D3B1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C7CD-83CD-4A60-979F-C46E1E8B2DB0}" type="datetimeFigureOut">
              <a:rPr lang="en-AU" smtClean="0"/>
              <a:t>1/03/2024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23A9E2-54E4-773B-F1CB-7D5A7C1E69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7A8481-FBA1-DBBE-0A9E-E3B279D729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0A19F-274B-46F8-BC63-B4A9E085F61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555036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A77144-D419-BE80-BA06-F59E08EAB6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575F116-1B8F-0BDB-AF78-9C87CA9A2A9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E20448-C24D-07C3-1936-D88F7CD176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C7CD-83CD-4A60-979F-C46E1E8B2DB0}" type="datetimeFigureOut">
              <a:rPr lang="en-AU" smtClean="0"/>
              <a:t>1/03/2024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CD1099-98BD-5310-311C-EBBA8D8869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6306EC-15D0-9EB8-4B1B-71A6BD339E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0A19F-274B-46F8-BC63-B4A9E085F61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578152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3EE6CF-2B30-C2AA-BEFF-F8934379DD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CCC0C9A-F171-12FB-03A8-538D14C327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06FCDE-1F83-6A5A-0187-502F85DBA5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C7CD-83CD-4A60-979F-C46E1E8B2DB0}" type="datetimeFigureOut">
              <a:rPr lang="en-AU" smtClean="0"/>
              <a:t>1/03/2024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55F131-1880-3FBD-336B-D6DCE4A3CE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3C706E-1A6C-3D7A-65EA-4A2C223320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0A19F-274B-46F8-BC63-B4A9E085F61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289238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7234C1-AD7D-A08E-B5E8-1CBDA1088B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B92718E-9B4F-6706-ABB5-6762A581D5E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5EEE5F8-557A-300E-B61D-1E8A3A018A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ACC6F58-246D-1827-915A-91DEE49ECB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C7CD-83CD-4A60-979F-C46E1E8B2DB0}" type="datetimeFigureOut">
              <a:rPr lang="en-AU" smtClean="0"/>
              <a:t>1/03/2024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089722D-BBFE-A2FC-43A8-0289B34756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E8BDE7F-BF8C-7BED-AD75-6B38F389D0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0A19F-274B-46F8-BC63-B4A9E085F61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648767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C0CF55-20C6-4141-7139-4956AB530E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181EF31-C4EE-E9C2-A4C0-7A7B1DAC41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4FF6509-8419-A4D9-23D3-A26E47B61C0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73B6C56-4F95-FBD2-40B8-F944A4EA1D7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F292C7B-E29A-4958-B9A1-E50BCCC7504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EE6D317-69C4-811A-2D36-DC744A59BA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C7CD-83CD-4A60-979F-C46E1E8B2DB0}" type="datetimeFigureOut">
              <a:rPr lang="en-AU" smtClean="0"/>
              <a:t>1/03/2024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47B1FB9-2449-E8A0-4C96-638213A0E0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4A72D8D-1ADF-B24C-A4C6-EC60D7031A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0A19F-274B-46F8-BC63-B4A9E085F61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244357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9DF1F1-A776-951C-3C7D-8278DD4188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3B8B877-D730-E08E-9FFD-C2E09DC0C8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C7CD-83CD-4A60-979F-C46E1E8B2DB0}" type="datetimeFigureOut">
              <a:rPr lang="en-AU" smtClean="0"/>
              <a:t>1/03/2024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73245C1-FB42-AD68-7D40-9E05E44546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B80CAB3-F32E-53DD-986B-AD46413B0C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0A19F-274B-46F8-BC63-B4A9E085F61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409086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2BE6525-1AF8-F769-A353-D0FBF2EFFD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C7CD-83CD-4A60-979F-C46E1E8B2DB0}" type="datetimeFigureOut">
              <a:rPr lang="en-AU" smtClean="0"/>
              <a:t>1/03/2024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DEE19BA-744B-CE37-7191-6A1855AD55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548E35D-7061-B5D0-697B-A411FF7744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0A19F-274B-46F8-BC63-B4A9E085F61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257020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A6EAD4-4BC5-92AB-4DDF-2C05615965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EB5F995-37F3-8921-C1AD-3D166C57B63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B9EA2B4-EAFD-B0B8-7EF4-2812127C35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7C985C8-E786-9B97-0503-2828E50626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C7CD-83CD-4A60-979F-C46E1E8B2DB0}" type="datetimeFigureOut">
              <a:rPr lang="en-AU" smtClean="0"/>
              <a:t>1/03/2024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030F2B-C9BA-E651-E1CE-4C5412F641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A77B84D-16BA-FA6A-8A9C-D3A452FB5F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0A19F-274B-46F8-BC63-B4A9E085F61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779475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A4A784-E216-5C6E-2B8A-12550831E9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D3FF126-EE25-B84E-948C-895D3F2B1AE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BCD1B23-0223-EF98-5F6C-72705861010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9540255-55B4-A424-34C0-85B8822D6E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C7CD-83CD-4A60-979F-C46E1E8B2DB0}" type="datetimeFigureOut">
              <a:rPr lang="en-AU" smtClean="0"/>
              <a:t>1/03/2024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7E0EFC8-A364-0542-EEE2-41756D8A72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455D571-4A91-BA48-B5FB-62643196AA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0A19F-274B-46F8-BC63-B4A9E085F61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659875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8510106-14CA-7120-88D1-CEA21E8750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0ACB0E2-82D1-23D9-A321-CC8A6E3E8D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9EB5D8-646B-12DC-5136-FDDEF4FBAA2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C9C7CD-83CD-4A60-979F-C46E1E8B2DB0}" type="datetimeFigureOut">
              <a:rPr lang="en-AU" smtClean="0"/>
              <a:t>1/03/2024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9C2C26-6E32-9A72-A8DA-1FB2C74080F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B3DB31-088D-49CE-0BA4-8AB81A0DAA5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00A19F-274B-46F8-BC63-B4A9E085F61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770545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409D4CAE-3850-F903-5709-DE55361D0BB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5979" y="1554555"/>
            <a:ext cx="11420467" cy="397997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7F1F1925-91FA-F6F8-B5D5-50BCCA418024}"/>
              </a:ext>
            </a:extLst>
          </p:cNvPr>
          <p:cNvSpPr txBox="1"/>
          <p:nvPr/>
        </p:nvSpPr>
        <p:spPr>
          <a:xfrm>
            <a:off x="342979" y="5497442"/>
            <a:ext cx="11351714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000" b="1" dirty="0"/>
              <a:t>Figure S1. </a:t>
            </a:r>
            <a:r>
              <a:rPr lang="en-AU" sz="1000" b="1" i="1" dirty="0"/>
              <a:t>TMPRSS15</a:t>
            </a:r>
            <a:r>
              <a:rPr lang="en-AU" sz="1000" b="1" i="0" dirty="0"/>
              <a:t> is expressed primarily in small intestinal tissue.</a:t>
            </a:r>
            <a:r>
              <a:rPr lang="en-AU" sz="1000" b="0" i="0" dirty="0"/>
              <a:t> Plot from the Genotype-Tissue Expression (</a:t>
            </a:r>
            <a:r>
              <a:rPr lang="en-AU" sz="1000" b="0" i="0" dirty="0" err="1"/>
              <a:t>GTEx</a:t>
            </a:r>
            <a:r>
              <a:rPr lang="en-AU" sz="1000" b="0" i="0" dirty="0"/>
              <a:t>) project showing </a:t>
            </a:r>
            <a:r>
              <a:rPr lang="en-AU" sz="1000" b="0" i="1" dirty="0"/>
              <a:t>TMPRSS15</a:t>
            </a:r>
            <a:r>
              <a:rPr lang="en-AU" sz="1000" b="0" i="0" dirty="0"/>
              <a:t> mRNA expression across 49 human tissues. TPM: transcripts per million.</a:t>
            </a:r>
            <a:endParaRPr lang="en-AU" sz="1000" b="1" dirty="0"/>
          </a:p>
        </p:txBody>
      </p:sp>
    </p:spTree>
    <p:extLst>
      <p:ext uri="{BB962C8B-B14F-4D97-AF65-F5344CB8AC3E}">
        <p14:creationId xmlns:p14="http://schemas.microsoft.com/office/powerpoint/2010/main" val="7860840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39</TotalTime>
  <Words>73</Words>
  <Application>Microsoft Office PowerPoint</Application>
  <PresentationFormat>Widescreen</PresentationFormat>
  <Paragraphs>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South Australi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Stacey</dc:creator>
  <cp:lastModifiedBy>David Stacey</cp:lastModifiedBy>
  <cp:revision>14</cp:revision>
  <dcterms:created xsi:type="dcterms:W3CDTF">2024-02-13T06:26:00Z</dcterms:created>
  <dcterms:modified xsi:type="dcterms:W3CDTF">2024-03-01T03:17:33Z</dcterms:modified>
</cp:coreProperties>
</file>